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150" d="100"/>
          <a:sy n="150" d="100"/>
        </p:scale>
        <p:origin x="1512" y="-4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08DBF-08B8-4836-BF25-0DCBBAABEF82}" type="datetimeFigureOut">
              <a:rPr kumimoji="1" lang="ja-JP" altLang="en-US" smtClean="0"/>
              <a:t>2023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E1B9C-4330-4FEB-89C2-895475DC0A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7354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08DBF-08B8-4836-BF25-0DCBBAABEF82}" type="datetimeFigureOut">
              <a:rPr kumimoji="1" lang="ja-JP" altLang="en-US" smtClean="0"/>
              <a:t>2023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E1B9C-4330-4FEB-89C2-895475DC0A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3509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08DBF-08B8-4836-BF25-0DCBBAABEF82}" type="datetimeFigureOut">
              <a:rPr kumimoji="1" lang="ja-JP" altLang="en-US" smtClean="0"/>
              <a:t>2023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E1B9C-4330-4FEB-89C2-895475DC0A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16851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08DBF-08B8-4836-BF25-0DCBBAABEF82}" type="datetimeFigureOut">
              <a:rPr kumimoji="1" lang="ja-JP" altLang="en-US" smtClean="0"/>
              <a:t>2023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E1B9C-4330-4FEB-89C2-895475DC0A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04103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08DBF-08B8-4836-BF25-0DCBBAABEF82}" type="datetimeFigureOut">
              <a:rPr kumimoji="1" lang="ja-JP" altLang="en-US" smtClean="0"/>
              <a:t>2023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E1B9C-4330-4FEB-89C2-895475DC0A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57901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08DBF-08B8-4836-BF25-0DCBBAABEF82}" type="datetimeFigureOut">
              <a:rPr kumimoji="1" lang="ja-JP" altLang="en-US" smtClean="0"/>
              <a:t>2023/9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E1B9C-4330-4FEB-89C2-895475DC0A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58106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08DBF-08B8-4836-BF25-0DCBBAABEF82}" type="datetimeFigureOut">
              <a:rPr kumimoji="1" lang="ja-JP" altLang="en-US" smtClean="0"/>
              <a:t>2023/9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E1B9C-4330-4FEB-89C2-895475DC0A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9110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08DBF-08B8-4836-BF25-0DCBBAABEF82}" type="datetimeFigureOut">
              <a:rPr kumimoji="1" lang="ja-JP" altLang="en-US" smtClean="0"/>
              <a:t>2023/9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E1B9C-4330-4FEB-89C2-895475DC0A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431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08DBF-08B8-4836-BF25-0DCBBAABEF82}" type="datetimeFigureOut">
              <a:rPr kumimoji="1" lang="ja-JP" altLang="en-US" smtClean="0"/>
              <a:t>2023/9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E1B9C-4330-4FEB-89C2-895475DC0A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31691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08DBF-08B8-4836-BF25-0DCBBAABEF82}" type="datetimeFigureOut">
              <a:rPr kumimoji="1" lang="ja-JP" altLang="en-US" smtClean="0"/>
              <a:t>2023/9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E1B9C-4330-4FEB-89C2-895475DC0A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6188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08DBF-08B8-4836-BF25-0DCBBAABEF82}" type="datetimeFigureOut">
              <a:rPr kumimoji="1" lang="ja-JP" altLang="en-US" smtClean="0"/>
              <a:t>2023/9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E1B9C-4330-4FEB-89C2-895475DC0A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84769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008DBF-08B8-4836-BF25-0DCBBAABEF82}" type="datetimeFigureOut">
              <a:rPr kumimoji="1" lang="ja-JP" altLang="en-US" smtClean="0"/>
              <a:t>2023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2E1B9C-4330-4FEB-89C2-895475DC0A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3652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フリーフォーム: 図形 39">
            <a:extLst>
              <a:ext uri="{FF2B5EF4-FFF2-40B4-BE49-F238E27FC236}">
                <a16:creationId xmlns:a16="http://schemas.microsoft.com/office/drawing/2014/main" id="{E7754ED5-FC5A-4238-87F4-AA6CC87A0B92}"/>
              </a:ext>
            </a:extLst>
          </p:cNvPr>
          <p:cNvSpPr/>
          <p:nvPr/>
        </p:nvSpPr>
        <p:spPr>
          <a:xfrm>
            <a:off x="1195070" y="2890202"/>
            <a:ext cx="2519680" cy="719455"/>
          </a:xfrm>
          <a:custGeom>
            <a:avLst/>
            <a:gdLst>
              <a:gd name="connsiteX0" fmla="*/ 0 w 5716302"/>
              <a:gd name="connsiteY0" fmla="*/ 333118 h 951141"/>
              <a:gd name="connsiteX1" fmla="*/ 2739258 w 5716302"/>
              <a:gd name="connsiteY1" fmla="*/ 333118 h 951141"/>
              <a:gd name="connsiteX2" fmla="*/ 2739258 w 5716302"/>
              <a:gd name="connsiteY2" fmla="*/ 237785 h 951141"/>
              <a:gd name="connsiteX3" fmla="*/ 2620366 w 5716302"/>
              <a:gd name="connsiteY3" fmla="*/ 237785 h 951141"/>
              <a:gd name="connsiteX4" fmla="*/ 2858151 w 5716302"/>
              <a:gd name="connsiteY4" fmla="*/ 0 h 951141"/>
              <a:gd name="connsiteX5" fmla="*/ 3095936 w 5716302"/>
              <a:gd name="connsiteY5" fmla="*/ 237785 h 951141"/>
              <a:gd name="connsiteX6" fmla="*/ 2977044 w 5716302"/>
              <a:gd name="connsiteY6" fmla="*/ 237785 h 951141"/>
              <a:gd name="connsiteX7" fmla="*/ 2977044 w 5716302"/>
              <a:gd name="connsiteY7" fmla="*/ 333118 h 951141"/>
              <a:gd name="connsiteX8" fmla="*/ 5716302 w 5716302"/>
              <a:gd name="connsiteY8" fmla="*/ 333118 h 951141"/>
              <a:gd name="connsiteX9" fmla="*/ 5716302 w 5716302"/>
              <a:gd name="connsiteY9" fmla="*/ 951141 h 951141"/>
              <a:gd name="connsiteX10" fmla="*/ 0 w 5716302"/>
              <a:gd name="connsiteY10" fmla="*/ 951141 h 951141"/>
              <a:gd name="connsiteX11" fmla="*/ 0 w 5716302"/>
              <a:gd name="connsiteY11" fmla="*/ 333118 h 95114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5716302" h="951141">
                <a:moveTo>
                  <a:pt x="5716302" y="618023"/>
                </a:moveTo>
                <a:lnTo>
                  <a:pt x="2977044" y="618023"/>
                </a:lnTo>
                <a:lnTo>
                  <a:pt x="2977044" y="713356"/>
                </a:lnTo>
                <a:lnTo>
                  <a:pt x="3095936" y="713356"/>
                </a:lnTo>
                <a:lnTo>
                  <a:pt x="2858151" y="951140"/>
                </a:lnTo>
                <a:lnTo>
                  <a:pt x="2620366" y="713356"/>
                </a:lnTo>
                <a:lnTo>
                  <a:pt x="2739258" y="713356"/>
                </a:lnTo>
                <a:lnTo>
                  <a:pt x="2739258" y="618023"/>
                </a:lnTo>
                <a:lnTo>
                  <a:pt x="0" y="618023"/>
                </a:lnTo>
                <a:lnTo>
                  <a:pt x="0" y="1"/>
                </a:lnTo>
                <a:lnTo>
                  <a:pt x="5716302" y="1"/>
                </a:lnTo>
                <a:lnTo>
                  <a:pt x="5716302" y="618023"/>
                </a:lnTo>
                <a:close/>
              </a:path>
            </a:pathLst>
          </a:custGeom>
          <a:ln w="190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spcFirstLastPara="0" vert="horz" wrap="square" lIns="170688" tIns="170689" rIns="170688" bIns="787980" numCol="1" spcCol="1270" anchor="ctr" anchorCtr="0">
            <a:noAutofit/>
          </a:bodyPr>
          <a:lstStyle/>
          <a:p>
            <a:endParaRPr lang="ja-JP" altLang="en-US" sz="1100"/>
          </a:p>
        </p:txBody>
      </p:sp>
      <p:sp>
        <p:nvSpPr>
          <p:cNvPr id="41" name="テキスト ボックス 26">
            <a:extLst>
              <a:ext uri="{FF2B5EF4-FFF2-40B4-BE49-F238E27FC236}">
                <a16:creationId xmlns:a16="http://schemas.microsoft.com/office/drawing/2014/main" id="{611207CF-4413-7515-CE6E-FE3CCBF2BD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39850" y="2929413"/>
            <a:ext cx="2095500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629</a:t>
            </a:r>
            <a:r>
              <a:rPr kumimoji="0" lang="en-US" altLang="ja-JP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participants age 65-84 years living in Bunkyo-</a:t>
            </a:r>
            <a:r>
              <a:rPr kumimoji="0" lang="en-US" altLang="ja-JP" sz="11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u</a:t>
            </a:r>
            <a:r>
              <a:rPr kumimoji="0" lang="en-US" altLang="ja-JP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endParaRPr kumimoji="0" lang="en-US" altLang="ja-JP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2" name="フリーフォーム: 図形 41">
            <a:extLst>
              <a:ext uri="{FF2B5EF4-FFF2-40B4-BE49-F238E27FC236}">
                <a16:creationId xmlns:a16="http://schemas.microsoft.com/office/drawing/2014/main" id="{F0A394F5-AAA6-B25C-DE76-C0DC5A12D29A}"/>
              </a:ext>
            </a:extLst>
          </p:cNvPr>
          <p:cNvSpPr/>
          <p:nvPr/>
        </p:nvSpPr>
        <p:spPr>
          <a:xfrm>
            <a:off x="1197610" y="3678237"/>
            <a:ext cx="2519680" cy="719455"/>
          </a:xfrm>
          <a:custGeom>
            <a:avLst/>
            <a:gdLst>
              <a:gd name="connsiteX0" fmla="*/ 0 w 5716302"/>
              <a:gd name="connsiteY0" fmla="*/ 333118 h 951141"/>
              <a:gd name="connsiteX1" fmla="*/ 2739258 w 5716302"/>
              <a:gd name="connsiteY1" fmla="*/ 333118 h 951141"/>
              <a:gd name="connsiteX2" fmla="*/ 2739258 w 5716302"/>
              <a:gd name="connsiteY2" fmla="*/ 237785 h 951141"/>
              <a:gd name="connsiteX3" fmla="*/ 2620366 w 5716302"/>
              <a:gd name="connsiteY3" fmla="*/ 237785 h 951141"/>
              <a:gd name="connsiteX4" fmla="*/ 2858151 w 5716302"/>
              <a:gd name="connsiteY4" fmla="*/ 0 h 951141"/>
              <a:gd name="connsiteX5" fmla="*/ 3095936 w 5716302"/>
              <a:gd name="connsiteY5" fmla="*/ 237785 h 951141"/>
              <a:gd name="connsiteX6" fmla="*/ 2977044 w 5716302"/>
              <a:gd name="connsiteY6" fmla="*/ 237785 h 951141"/>
              <a:gd name="connsiteX7" fmla="*/ 2977044 w 5716302"/>
              <a:gd name="connsiteY7" fmla="*/ 333118 h 951141"/>
              <a:gd name="connsiteX8" fmla="*/ 5716302 w 5716302"/>
              <a:gd name="connsiteY8" fmla="*/ 333118 h 951141"/>
              <a:gd name="connsiteX9" fmla="*/ 5716302 w 5716302"/>
              <a:gd name="connsiteY9" fmla="*/ 951141 h 951141"/>
              <a:gd name="connsiteX10" fmla="*/ 0 w 5716302"/>
              <a:gd name="connsiteY10" fmla="*/ 951141 h 951141"/>
              <a:gd name="connsiteX11" fmla="*/ 0 w 5716302"/>
              <a:gd name="connsiteY11" fmla="*/ 333118 h 95114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5716302" h="951141">
                <a:moveTo>
                  <a:pt x="5716302" y="618023"/>
                </a:moveTo>
                <a:lnTo>
                  <a:pt x="2977044" y="618023"/>
                </a:lnTo>
                <a:lnTo>
                  <a:pt x="2977044" y="713356"/>
                </a:lnTo>
                <a:lnTo>
                  <a:pt x="3095936" y="713356"/>
                </a:lnTo>
                <a:lnTo>
                  <a:pt x="2858151" y="951140"/>
                </a:lnTo>
                <a:lnTo>
                  <a:pt x="2620366" y="713356"/>
                </a:lnTo>
                <a:lnTo>
                  <a:pt x="2739258" y="713356"/>
                </a:lnTo>
                <a:lnTo>
                  <a:pt x="2739258" y="618023"/>
                </a:lnTo>
                <a:lnTo>
                  <a:pt x="0" y="618023"/>
                </a:lnTo>
                <a:lnTo>
                  <a:pt x="0" y="1"/>
                </a:lnTo>
                <a:lnTo>
                  <a:pt x="5716302" y="1"/>
                </a:lnTo>
                <a:lnTo>
                  <a:pt x="5716302" y="618023"/>
                </a:lnTo>
                <a:close/>
              </a:path>
            </a:pathLst>
          </a:custGeom>
          <a:ln w="190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spcFirstLastPara="0" vert="horz" wrap="square" lIns="170688" tIns="170689" rIns="170688" bIns="787980" numCol="1" spcCol="1270" anchor="ctr" anchorCtr="0">
            <a:noAutofit/>
          </a:bodyPr>
          <a:lstStyle/>
          <a:p>
            <a:endParaRPr lang="ja-JP" altLang="en-US" sz="1100"/>
          </a:p>
        </p:txBody>
      </p:sp>
      <p:sp>
        <p:nvSpPr>
          <p:cNvPr id="43" name="Text Box 58">
            <a:extLst>
              <a:ext uri="{FF2B5EF4-FFF2-40B4-BE49-F238E27FC236}">
                <a16:creationId xmlns:a16="http://schemas.microsoft.com/office/drawing/2014/main" id="{5F35FB09-476E-AE23-2A7A-A1F76156C2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36211" y="3777137"/>
            <a:ext cx="2033587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565</a:t>
            </a:r>
            <a:r>
              <a:rPr kumimoji="0" lang="en-US" altLang="ja-JP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participants</a:t>
            </a:r>
            <a:endParaRPr kumimoji="0" lang="en-US" altLang="ja-JP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44" name="直線矢印コネクタ 43">
            <a:extLst>
              <a:ext uri="{FF2B5EF4-FFF2-40B4-BE49-F238E27FC236}">
                <a16:creationId xmlns:a16="http://schemas.microsoft.com/office/drawing/2014/main" id="{F8776AAD-AD44-A91E-E68B-50026E3AB201}"/>
              </a:ext>
            </a:extLst>
          </p:cNvPr>
          <p:cNvCxnSpPr/>
          <p:nvPr/>
        </p:nvCxnSpPr>
        <p:spPr>
          <a:xfrm>
            <a:off x="2713990" y="3492182"/>
            <a:ext cx="2159635" cy="0"/>
          </a:xfrm>
          <a:prstGeom prst="straightConnector1">
            <a:avLst/>
          </a:prstGeom>
          <a:ln w="19050">
            <a:prstDash val="sysDash"/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正方形/長方形 16">
            <a:extLst>
              <a:ext uri="{FF2B5EF4-FFF2-40B4-BE49-F238E27FC236}">
                <a16:creationId xmlns:a16="http://schemas.microsoft.com/office/drawing/2014/main" id="{8EDDD12F-941A-D4C8-2C59-B321ABF8210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18597" y="2929413"/>
            <a:ext cx="1871346" cy="688815"/>
          </a:xfrm>
          <a:prstGeom prst="rect">
            <a:avLst/>
          </a:prstGeom>
          <a:solidFill>
            <a:srgbClr val="D9D9D9"/>
          </a:solidFill>
          <a:ln w="1587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xcluded</a:t>
            </a:r>
          </a:p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-Incomplete masseter muscle volume data</a:t>
            </a:r>
            <a:r>
              <a:rPr lang="ja-JP" alt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n=64)</a:t>
            </a:r>
            <a:endParaRPr kumimoji="0" lang="en-US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46" name="直線矢印コネクタ 45">
            <a:extLst>
              <a:ext uri="{FF2B5EF4-FFF2-40B4-BE49-F238E27FC236}">
                <a16:creationId xmlns:a16="http://schemas.microsoft.com/office/drawing/2014/main" id="{B6C0E9CF-2312-4D09-235C-00E75A6FD09D}"/>
              </a:ext>
            </a:extLst>
          </p:cNvPr>
          <p:cNvCxnSpPr/>
          <p:nvPr/>
        </p:nvCxnSpPr>
        <p:spPr>
          <a:xfrm>
            <a:off x="2595880" y="4309427"/>
            <a:ext cx="2159635" cy="0"/>
          </a:xfrm>
          <a:prstGeom prst="straightConnector1">
            <a:avLst/>
          </a:prstGeom>
          <a:ln w="19050">
            <a:prstDash val="sysDash"/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Rectangle 54">
            <a:extLst>
              <a:ext uri="{FF2B5EF4-FFF2-40B4-BE49-F238E27FC236}">
                <a16:creationId xmlns:a16="http://schemas.microsoft.com/office/drawing/2014/main" id="{23E59DB7-2E44-D4BB-C921-35C9818D6E0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33361" y="3668871"/>
            <a:ext cx="1871345" cy="1213089"/>
          </a:xfrm>
          <a:prstGeom prst="rect">
            <a:avLst/>
          </a:prstGeom>
          <a:solidFill>
            <a:srgbClr val="D9D9D9"/>
          </a:solidFill>
          <a:ln w="1587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xcluded</a:t>
            </a:r>
          </a:p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-</a:t>
            </a: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erebrovascular disease (n=66)</a:t>
            </a:r>
            <a:endParaRPr kumimoji="0" lang="en-US" altLang="ja-JP" sz="3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-</a:t>
            </a: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issing data of body composition/function and genotype  (n=15)</a:t>
            </a:r>
            <a:endParaRPr kumimoji="0" lang="en-US" altLang="ja-JP" sz="3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8" name="フリーフォーム: 図形 47">
            <a:extLst>
              <a:ext uri="{FF2B5EF4-FFF2-40B4-BE49-F238E27FC236}">
                <a16:creationId xmlns:a16="http://schemas.microsoft.com/office/drawing/2014/main" id="{F9774502-C086-484A-A81A-F00A3F5E964E}"/>
              </a:ext>
            </a:extLst>
          </p:cNvPr>
          <p:cNvSpPr/>
          <p:nvPr/>
        </p:nvSpPr>
        <p:spPr>
          <a:xfrm>
            <a:off x="1193165" y="4473257"/>
            <a:ext cx="2519680" cy="471805"/>
          </a:xfrm>
          <a:custGeom>
            <a:avLst/>
            <a:gdLst>
              <a:gd name="connsiteX0" fmla="*/ 0 w 5716302"/>
              <a:gd name="connsiteY0" fmla="*/ 0 h 618427"/>
              <a:gd name="connsiteX1" fmla="*/ 5716302 w 5716302"/>
              <a:gd name="connsiteY1" fmla="*/ 0 h 618427"/>
              <a:gd name="connsiteX2" fmla="*/ 5716302 w 5716302"/>
              <a:gd name="connsiteY2" fmla="*/ 618427 h 618427"/>
              <a:gd name="connsiteX3" fmla="*/ 0 w 5716302"/>
              <a:gd name="connsiteY3" fmla="*/ 618427 h 618427"/>
              <a:gd name="connsiteX4" fmla="*/ 0 w 5716302"/>
              <a:gd name="connsiteY4" fmla="*/ 0 h 61842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716302" h="618427">
                <a:moveTo>
                  <a:pt x="0" y="0"/>
                </a:moveTo>
                <a:lnTo>
                  <a:pt x="5716302" y="0"/>
                </a:lnTo>
                <a:lnTo>
                  <a:pt x="5716302" y="618427"/>
                </a:lnTo>
                <a:lnTo>
                  <a:pt x="0" y="618427"/>
                </a:lnTo>
                <a:lnTo>
                  <a:pt x="0" y="0"/>
                </a:lnTo>
                <a:close/>
              </a:path>
            </a:pathLst>
          </a:custGeom>
          <a:ln w="190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spcFirstLastPara="0" vert="horz" wrap="square" lIns="170688" tIns="170688" rIns="170688" bIns="455165" numCol="1" spcCol="1270" anchor="ctr" anchorCtr="0">
            <a:noAutofit/>
          </a:bodyPr>
          <a:lstStyle/>
          <a:p>
            <a:endParaRPr lang="ja-JP" altLang="en-US" sz="1100"/>
          </a:p>
        </p:txBody>
      </p:sp>
      <p:sp>
        <p:nvSpPr>
          <p:cNvPr id="49" name="Text Box 52">
            <a:extLst>
              <a:ext uri="{FF2B5EF4-FFF2-40B4-BE49-F238E27FC236}">
                <a16:creationId xmlns:a16="http://schemas.microsoft.com/office/drawing/2014/main" id="{82BEA308-235F-E7BD-0D4C-05478A9634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70806" y="4512308"/>
            <a:ext cx="2033588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484 </a:t>
            </a:r>
            <a:r>
              <a:rPr kumimoji="0" lang="en-US" altLang="ja-JP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nal analysis participants</a:t>
            </a:r>
            <a:endParaRPr kumimoji="0" lang="en-US" altLang="ja-JP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en: 603, </a:t>
            </a:r>
            <a:r>
              <a:rPr lang="en-US" altLang="ja-JP" sz="1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women</a:t>
            </a:r>
            <a:r>
              <a:rPr kumimoji="0" lang="en-US" altLang="ja-JP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: 881</a:t>
            </a:r>
            <a:endParaRPr kumimoji="0" lang="en-US" altLang="ja-JP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5F48933C-5AAC-1A5B-E93D-778CEEB13832}"/>
              </a:ext>
            </a:extLst>
          </p:cNvPr>
          <p:cNvSpPr txBox="1"/>
          <p:nvPr/>
        </p:nvSpPr>
        <p:spPr>
          <a:xfrm>
            <a:off x="881380" y="1795959"/>
            <a:ext cx="3429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1</a:t>
            </a:r>
            <a:endParaRPr kumimoji="0" lang="en-US" altLang="ja-JP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42258250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A48ED141-D762-E46C-2AF1-A02897A0DF08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/>
          </a:p>
        </p:txBody>
      </p:sp>
      <p:pic>
        <p:nvPicPr>
          <p:cNvPr id="3073" name="図 21" descr="テレビゲームの画面のスクリーンショット&#10;&#10;低い精度で自動的に生成された説明">
            <a:extLst>
              <a:ext uri="{FF2B5EF4-FFF2-40B4-BE49-F238E27FC236}">
                <a16:creationId xmlns:a16="http://schemas.microsoft.com/office/drawing/2014/main" id="{6CA36882-A990-2975-F07E-2AC73330031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4745" y="1853119"/>
            <a:ext cx="4995230" cy="66427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>
            <a:extLst>
              <a:ext uri="{FF2B5EF4-FFF2-40B4-BE49-F238E27FC236}">
                <a16:creationId xmlns:a16="http://schemas.microsoft.com/office/drawing/2014/main" id="{499A3C91-DE76-070B-ADD6-4B397BDD44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9620" y="603394"/>
            <a:ext cx="5745480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b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rPr>
            </a:b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2</a:t>
            </a:r>
            <a:endParaRPr kumimoji="0" lang="en-US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08932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7795B0E4-AD36-1DC1-6271-EAAF7F60E8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/>
          </a:p>
        </p:txBody>
      </p:sp>
      <p:pic>
        <p:nvPicPr>
          <p:cNvPr id="4097" name="図 19" descr="Web サイト が含まれている画像&#10;&#10;自動的に生成された説明">
            <a:extLst>
              <a:ext uri="{FF2B5EF4-FFF2-40B4-BE49-F238E27FC236}">
                <a16:creationId xmlns:a16="http://schemas.microsoft.com/office/drawing/2014/main" id="{B7625A63-5CF7-4F5A-9964-58AFDD4CA54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2492" y="2869565"/>
            <a:ext cx="5434723" cy="35159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>
            <a:extLst>
              <a:ext uri="{FF2B5EF4-FFF2-40B4-BE49-F238E27FC236}">
                <a16:creationId xmlns:a16="http://schemas.microsoft.com/office/drawing/2014/main" id="{AB6ED654-6C13-29F1-FBC3-7CDD9D8F53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270302"/>
            <a:ext cx="787395" cy="8309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b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</a:b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</a:t>
            </a:r>
            <a:r>
              <a:rPr kumimoji="0" lang="en-US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D55F6CC1-67D8-779F-4A24-095EF0429FCD}"/>
              </a:ext>
            </a:extLst>
          </p:cNvPr>
          <p:cNvSpPr/>
          <p:nvPr/>
        </p:nvSpPr>
        <p:spPr>
          <a:xfrm>
            <a:off x="898842" y="3810000"/>
            <a:ext cx="637858" cy="177800"/>
          </a:xfrm>
          <a:prstGeom prst="rect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52AB4AEB-2F0E-F1A1-A2E6-ACF16432859B}"/>
              </a:ext>
            </a:extLst>
          </p:cNvPr>
          <p:cNvSpPr/>
          <p:nvPr/>
        </p:nvSpPr>
        <p:spPr>
          <a:xfrm>
            <a:off x="5640229" y="3810000"/>
            <a:ext cx="637858" cy="177800"/>
          </a:xfrm>
          <a:prstGeom prst="rect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26895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27</TotalTime>
  <Words>65</Words>
  <Application>Microsoft Office PowerPoint</Application>
  <PresentationFormat>A4 210 x 297 mm</PresentationFormat>
  <Paragraphs>14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oshifumi Tamura</dc:creator>
  <cp:lastModifiedBy>Yoshifumi Tamura</cp:lastModifiedBy>
  <cp:revision>8</cp:revision>
  <dcterms:created xsi:type="dcterms:W3CDTF">2023-06-29T02:13:35Z</dcterms:created>
  <dcterms:modified xsi:type="dcterms:W3CDTF">2023-09-30T02:19:20Z</dcterms:modified>
</cp:coreProperties>
</file>